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98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13C0AA-DFE8-4F57-8FF8-4DD17E05B3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C4F5532-66C6-421A-A495-B539AA7D75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E761027-ADC7-40B7-8337-00A10F88A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A78382-2EE3-4F95-B592-F79CEB871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CC97FE4-206A-4F3E-826B-5EB376826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299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A2FAA2-FB63-4DCE-91CB-85E2F31BE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688AD95-639B-4FFF-933E-4AD7203C2D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233C89-9A67-4A10-AD9F-1714FD776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4942EB-4CA2-4B36-8B75-DD45F686E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8BE26DC-DFCA-4528-BBF1-0681AEDD6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167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E609105-7124-4B6D-9937-9F4FB36319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B14C2C4-BE1D-4A8F-8943-CE3753829B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1B5C4A-4239-4116-AE83-0D9C9F987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37426A-0632-4D68-99B8-153004D24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782262-AD98-4FC0-9D06-01578349F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7175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A0ABAC-360D-44E3-BC18-21E5E402D0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4EAC05D-2DC6-46F9-B9C1-AEB4856E8A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0D0FB0-1117-4BCC-B384-23882EC97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335376-4624-4827-A6AC-8F923B0E2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4F3270-2117-4861-8C02-C24F7077F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5339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7DDE65-7DD0-4F38-920F-07D8857A4B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588502B-85BB-4FAF-BB0C-4EDC282D57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7409106-AF19-4A6D-8C67-7754C0A25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DF11E58-ADF7-4565-B72D-DD9034568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B85B87F-56C2-44E3-9E13-7BF56D4B5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5113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C3DC50-8D58-46E7-916D-56A4C21BFD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1989AC8-D3E1-48D8-8255-FD1F5DC047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6456867-92C0-48B0-91CC-A9C862B15E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4EC77BE-AF97-4A1A-9FB2-A538101685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F6D5E25-BCE7-4457-ABAC-484BCE23D3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E290686-088D-45CA-B766-6FA9852D2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4035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D23463-E6D9-4590-89FF-C25439E3C5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9631355-407C-415F-A6D0-16DC0C4D76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DC998D6-E9E3-4E83-BDBF-3111211A78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818F09A-146F-4496-A6E8-D11E2333BB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D92F4FB-2C35-4863-8C3A-A6B2292C81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FD19559-FEFC-4151-844D-CC227BA1D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20F1724-5BB8-448A-8A96-AA7763B403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D8412B0-06EA-4B0C-8AD6-2584897C54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705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4E4857-CE88-4733-9BFD-922F9CCAE2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57760C3-C2C0-4EDE-9DFA-1F21E25EB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6DD25AC-3FF8-415C-A570-62894FDE05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27EE85B-3BF6-414F-A105-88DACF98A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162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D5F0392-98A0-450C-9D64-4C3F1CB12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74C43C4-26FF-44B3-8712-0C79B2C6D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DF2DEB0-0503-4660-AA91-D28FEA469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139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DF21BC-D7F3-4978-94CB-23BE6686DC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BE12B54-C898-46D7-804E-0D1B0EEA63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A985ECE-235B-486D-B50F-AEAEF31FB2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C648685-3D85-4B8E-9B32-A70C8CD95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8AAB70-AC7A-4F1A-AD9B-22DE4FA7B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82F38DA-AD13-470C-A58F-D57AF545E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27936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C3D18D-2714-44B2-992B-987F970C45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773B294-EFD1-435D-9996-32E3DF9A8C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DFBBCFB-8BE7-45C9-8F0F-B080B080F1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10EE9C8-07DC-4421-8E30-4DFD27F96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BB0D44-606E-4299-BA42-F79E01CC2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5B7B040-8A5E-4E9A-9E33-830995BA2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273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7171BB8-CD92-4894-94B7-724AAD47FD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81DB220-6559-4A47-A6AF-D1C823D2BD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6C60A4-A1D4-4C66-8371-DF4865289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496F93-DE3B-4219-9A94-D83050DA3DB7}" type="datetimeFigureOut">
              <a:rPr kumimoji="1" lang="ja-JP" altLang="en-US" smtClean="0"/>
              <a:t>2022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98DE6FA-72C8-4F1D-8A99-EF05121B81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031EDB-C4D8-44AD-A066-72A6963B41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48D1B-F022-4232-A084-6343AF1078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982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DB5F68E-1FED-493C-90DA-572B5E090931}"/>
              </a:ext>
            </a:extLst>
          </p:cNvPr>
          <p:cNvSpPr txBox="1"/>
          <p:nvPr/>
        </p:nvSpPr>
        <p:spPr>
          <a:xfrm>
            <a:off x="-1748117" y="223041"/>
            <a:ext cx="9502588" cy="3570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able 4. 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Univariate and multivariate analyses of predictive factors using logistic regression analysis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D63EA10-6611-4BA7-9DBD-5E187BC72CB3}"/>
              </a:ext>
            </a:extLst>
          </p:cNvPr>
          <p:cNvSpPr txBox="1"/>
          <p:nvPr/>
        </p:nvSpPr>
        <p:spPr>
          <a:xfrm>
            <a:off x="2277036" y="6087772"/>
            <a:ext cx="8097370" cy="6647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1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GPS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odified Glasgow Prognostic Score; NLR: neutrophil-to-lymphocyte ratio; PLR: platelet-to-lymphocyte ratio; PNI: prognostic nutritional index; PMI: psoas muscle mass index; CA19-9: carbohydrate antigen 19-9; CRP: C-reactive protein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0" name="オブジェクト 9">
            <a:extLst>
              <a:ext uri="{FF2B5EF4-FFF2-40B4-BE49-F238E27FC236}">
                <a16:creationId xmlns:a16="http://schemas.microsoft.com/office/drawing/2014/main" id="{7A21CF73-8CAD-4EF0-BDCF-EBDA71B470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0532048"/>
              </p:ext>
            </p:extLst>
          </p:nvPr>
        </p:nvGraphicFramePr>
        <p:xfrm>
          <a:off x="4083843" y="669635"/>
          <a:ext cx="4024313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Worksheet" r:id="rId3" imgW="8374162" imgH="11277545" progId="Excel.Sheet.12">
                  <p:embed/>
                </p:oleObj>
              </mc:Choice>
              <mc:Fallback>
                <p:oleObj name="Worksheet" r:id="rId3" imgW="8374162" imgH="11277545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83843" y="669635"/>
                        <a:ext cx="4024313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80668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Microsoft Excel ワークシー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梅澤 早織</dc:creator>
  <cp:lastModifiedBy>梅澤 早織</cp:lastModifiedBy>
  <cp:revision>1</cp:revision>
  <dcterms:created xsi:type="dcterms:W3CDTF">2022-03-27T04:02:27Z</dcterms:created>
  <dcterms:modified xsi:type="dcterms:W3CDTF">2022-03-27T04:03:41Z</dcterms:modified>
</cp:coreProperties>
</file>